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56" userDrawn="1">
          <p15:clr>
            <a:srgbClr val="A4A3A4"/>
          </p15:clr>
        </p15:guide>
        <p15:guide id="2" pos="354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51" d="100"/>
          <a:sy n="51" d="100"/>
        </p:scale>
        <p:origin x="108" y="360"/>
      </p:cViewPr>
      <p:guideLst>
        <p:guide orient="horz" pos="1956"/>
        <p:guide pos="35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6021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3450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9345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4617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3140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811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135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0069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1503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1159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2370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0B381-B9F7-46AE-AE3D-CA72B4B38742}" type="datetimeFigureOut">
              <a:rPr lang="es-ES" smtClean="0"/>
              <a:t>01/03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FDE45A-7F37-4EAF-90E9-C134F0F36E5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6685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499142" y="4818061"/>
            <a:ext cx="11257831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1.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ffect of </a:t>
            </a:r>
            <a:r>
              <a:rPr lang="en-US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coxin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n intracellular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OS levels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dirty="0">
                <a:solidFill>
                  <a:srgbClr val="FF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ime course and dose-response analysis of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OS levels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 HSC treated with </a:t>
            </a:r>
            <a:r>
              <a:rPr lang="en-US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coxin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SC were exposed for 1, 2 and 6 h to different dilutions of </a:t>
            </a:r>
            <a:r>
              <a:rPr lang="en-US" dirty="0" err="1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coxin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1:50, 1:100 and 1:500). Intracellular content of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OS was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etermined by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luorimetry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using CM-H</a:t>
            </a:r>
            <a:r>
              <a:rPr lang="en-US" baseline="-25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CFDA as a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obe.</a:t>
            </a:r>
            <a:r>
              <a:rPr lang="en-US" dirty="0" smtClean="0">
                <a:solidFill>
                  <a:srgbClr val="FF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ach bar represents the mean + SD of fluorescence fold change compared to controls of at least quadruplicate experiments </a:t>
            </a:r>
            <a:r>
              <a:rPr lang="en-US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**p&lt;0.01, </a:t>
            </a:r>
            <a:r>
              <a:rPr lang="en-US" i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s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ntrol).</a:t>
            </a:r>
            <a:endParaRPr lang="es-ES" dirty="0"/>
          </a:p>
        </p:txBody>
      </p:sp>
      <p:sp>
        <p:nvSpPr>
          <p:cNvPr id="7" name="Rectángulo 6"/>
          <p:cNvSpPr/>
          <p:nvPr/>
        </p:nvSpPr>
        <p:spPr>
          <a:xfrm>
            <a:off x="4541727" y="710577"/>
            <a:ext cx="31726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ntracellular </a:t>
            </a:r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levels of ROS 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7" b="34576"/>
          <a:stretch/>
        </p:blipFill>
        <p:spPr>
          <a:xfrm>
            <a:off x="3330053" y="946638"/>
            <a:ext cx="6041327" cy="2902031"/>
          </a:xfrm>
          <a:prstGeom prst="rect">
            <a:avLst/>
          </a:prstGeom>
        </p:spPr>
      </p:pic>
      <p:sp>
        <p:nvSpPr>
          <p:cNvPr id="9" name="Rectángulo 8"/>
          <p:cNvSpPr/>
          <p:nvPr/>
        </p:nvSpPr>
        <p:spPr>
          <a:xfrm rot="16200000">
            <a:off x="2123313" y="2301802"/>
            <a:ext cx="20441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OS fold change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ángulo 13"/>
          <p:cNvSpPr/>
          <p:nvPr/>
        </p:nvSpPr>
        <p:spPr>
          <a:xfrm>
            <a:off x="6234164" y="4208505"/>
            <a:ext cx="88036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err="1" smtClean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Ocoxin</a:t>
            </a:r>
            <a:endParaRPr lang="es-E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ángulo 14"/>
          <p:cNvSpPr/>
          <p:nvPr/>
        </p:nvSpPr>
        <p:spPr>
          <a:xfrm>
            <a:off x="4104444" y="3788076"/>
            <a:ext cx="91403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ontrol</a:t>
            </a:r>
            <a:endParaRPr lang="es-E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ángulo 16"/>
          <p:cNvSpPr/>
          <p:nvPr/>
        </p:nvSpPr>
        <p:spPr>
          <a:xfrm>
            <a:off x="5345108" y="3788076"/>
            <a:ext cx="63299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:50</a:t>
            </a:r>
            <a:endParaRPr lang="es-E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ángulo 17"/>
          <p:cNvSpPr/>
          <p:nvPr/>
        </p:nvSpPr>
        <p:spPr>
          <a:xfrm>
            <a:off x="6373882" y="3788076"/>
            <a:ext cx="708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:100</a:t>
            </a:r>
            <a:endParaRPr lang="es-E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ángulo 18"/>
          <p:cNvSpPr/>
          <p:nvPr/>
        </p:nvSpPr>
        <p:spPr>
          <a:xfrm>
            <a:off x="7497278" y="3788076"/>
            <a:ext cx="708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smtClean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:500</a:t>
            </a:r>
            <a:endParaRPr lang="es-E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Conector recto 19"/>
          <p:cNvCxnSpPr/>
          <p:nvPr/>
        </p:nvCxnSpPr>
        <p:spPr>
          <a:xfrm>
            <a:off x="5310404" y="4140278"/>
            <a:ext cx="306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ángulo 12"/>
          <p:cNvSpPr/>
          <p:nvPr/>
        </p:nvSpPr>
        <p:spPr>
          <a:xfrm>
            <a:off x="9062077" y="6470276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figure 1. 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558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48</TotalTime>
  <Words>104</Words>
  <Application>Microsoft Office PowerPoint</Application>
  <PresentationFormat>Panorámica</PresentationFormat>
  <Paragraphs>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Palatino Linotype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duardo Ansorena Artieda</dc:creator>
  <cp:lastModifiedBy>Eduardo Ansorena Artieda</cp:lastModifiedBy>
  <cp:revision>10</cp:revision>
  <dcterms:created xsi:type="dcterms:W3CDTF">2021-06-04T11:52:10Z</dcterms:created>
  <dcterms:modified xsi:type="dcterms:W3CDTF">2022-03-01T16:50:43Z</dcterms:modified>
</cp:coreProperties>
</file>